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8DC9DD3-0943-45BA-B8E4-22EF0BC6DBC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D36EF34E-F854-4EF2-9B1F-3D382C1FB2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9BD92D8-C402-486A-A555-D340BD699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16EE3E11-7C13-4FF4-B882-8C308063E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EB8BD101-E9C2-4C7B-AA5B-31B65911EB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56783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1B6D77B-A59F-44CC-B991-7FC4C45C39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27052EA-A13E-4EFD-BDEE-E591F43C83E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51711CFE-5B64-4A56-880F-5433132985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BC25AC6-A358-47DF-9786-1025E0FFD4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4DE392D3-755D-4C3C-BD2F-CB4F92437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6520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38D70267-C1A1-4402-B56F-D28FA28F304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C9794004-CF29-40BE-AC56-7C6A3D0051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72527A7-1937-47FD-A5B5-26FF7AE983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7F1BF49-A7A0-4550-8F9F-2D3A0D0AC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62636F1-5C6E-485D-9617-108F936DD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00298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DD116E4-1011-42EA-9614-B4B203DEE9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366D05F-ED63-463F-BA15-900A80418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8A6823A-BB33-40DA-ADE8-A37B92917D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4496A95-08AF-4F4B-987E-6BD44C70A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CCE5780-939F-4EB8-A6F2-0AC097E8C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226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4E2C081-320F-4769-8ECE-BB14DC11A5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937F5CE-A565-48CE-8626-7EE2C28D18B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0813715-7672-4258-AB58-CC7046F843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2BD90FF-8E0D-43ED-BD14-7769E084A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39880262-4310-4B31-9A06-AC73C4467F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89285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ED26B78-7297-408C-95D0-FA8C4C2EB4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33CFB424-34E5-4F73-A4CB-69C99C7F7EC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FEAC2B8D-1BB7-47A3-AA04-3B2BC4F37B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7C950E8-2D01-45E9-A356-2ED19B717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7E520F5-9082-48D1-A13B-E6A1FB944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92797F53-426A-4CFE-8B44-588CE534AE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78523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3FC610C-7A06-4FB7-808D-ED8BE2CFAB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4D4B9ED1-99C1-497A-A2CA-9384333838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0153372B-4E02-4237-917D-414CB19EED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1819775D-21D6-440B-B26E-84E41E4ABC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F2E84300-18BD-45B3-BE88-9B3774DAD24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CEF91F3D-96D8-46CB-8158-F80734814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289A137A-8667-47B3-A70D-1B7AF7B75D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7BE3F2AC-BB33-4A75-8BDF-1418483F9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849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A3D83A18-9DB3-44DA-9EAD-9E325C0FD8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E6597F93-04AE-431C-8E88-D5BAC4D60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8D9693C-C6FF-4B25-9309-23DE8D0162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D08C570-BDC3-483D-97FD-25D306EC12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97891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669CBE93-CE74-45FB-82BD-733B15E8A8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A836CF89-2010-4EFA-9AC4-28EC8029D4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B2FB95D2-62B3-4AAB-9A51-404B1ABF60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82398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4830444-7FA1-4A4E-9D58-AE8018A3BA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88DB6D9-5A0E-4FB4-98A8-546F3AC3889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4E062B49-7089-4DBA-A091-F0E5B0643F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25EC6C1-BF0D-4F70-85BF-6F01CE862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05A28BC-8097-4843-A043-1708904132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B5C349B-5B4F-4710-8F17-C72FD1050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912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B46CD0C-25F1-4AE2-B3D0-98B722C00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E9FF7594-AF01-4D86-951C-3C6BB6AC707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E8B47A3-1875-4DC5-A2BE-33952EC5D1B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BDB525D7-95A3-4AFD-ABAD-D6467A3715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DE1F757D-243E-4001-BA31-FDB137760C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3B9E4BAF-0396-4106-AB8C-5D2FB1A580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1411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7BA3DF5B-ABC2-4E8D-8267-4DB78C66C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E07A745-5C15-46AD-93C9-4A6B697CC2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83557B3-60F4-4E01-B1F9-194539E21A6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861028-42FC-420C-AFC6-DC40E68FB494}" type="datetimeFigureOut">
              <a:rPr lang="en-GB" smtClean="0"/>
              <a:t>07/09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DCF4774-AAF4-42FB-A1DA-E9428088C47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F95D2F0B-C5D9-4EE4-B8B6-2EE30DBDD1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6168FE-FC57-41DF-8F9A-462172202EC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5690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65C9B387-3791-4953-874C-7C615FAA969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979" r="8410" b="79078"/>
          <a:stretch/>
        </p:blipFill>
        <p:spPr>
          <a:xfrm rot="10800000">
            <a:off x="944074" y="1913664"/>
            <a:ext cx="4161326" cy="363110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0F16FABD-CB36-4FCE-AC25-8A113825B52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428" t="62909" r="11678" b="-1"/>
          <a:stretch/>
        </p:blipFill>
        <p:spPr>
          <a:xfrm>
            <a:off x="944074" y="1434899"/>
            <a:ext cx="4161326" cy="363112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7781A996-818A-479F-A644-9898A665FA2C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9892" r="8410" b="31458"/>
          <a:stretch/>
        </p:blipFill>
        <p:spPr>
          <a:xfrm rot="10800000">
            <a:off x="944074" y="1079842"/>
            <a:ext cx="4161326" cy="225264"/>
          </a:xfrm>
          <a:prstGeom prst="rect">
            <a:avLst/>
          </a:prstGeom>
          <a:ln w="12700">
            <a:solidFill>
              <a:schemeClr val="tx1"/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873AFBE7-F6A3-4849-94A6-0F3035D7CB5A}"/>
              </a:ext>
            </a:extLst>
          </p:cNvPr>
          <p:cNvSpPr txBox="1"/>
          <p:nvPr/>
        </p:nvSpPr>
        <p:spPr>
          <a:xfrm>
            <a:off x="5125796" y="1079841"/>
            <a:ext cx="44916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DAF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42BEAE74-6945-4AB8-86FB-AB420BA34D77}"/>
              </a:ext>
            </a:extLst>
          </p:cNvPr>
          <p:cNvSpPr txBox="1"/>
          <p:nvPr/>
        </p:nvSpPr>
        <p:spPr>
          <a:xfrm>
            <a:off x="5105400" y="2016673"/>
            <a:ext cx="6479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54A58752-DC86-49B3-B3B9-B307CC9094DB}"/>
              </a:ext>
            </a:extLst>
          </p:cNvPr>
          <p:cNvSpPr txBox="1"/>
          <p:nvPr/>
        </p:nvSpPr>
        <p:spPr>
          <a:xfrm>
            <a:off x="5125796" y="143700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rry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xmlns="" id="{385B772D-3261-47E8-A342-DAF48405E43B}"/>
              </a:ext>
            </a:extLst>
          </p:cNvPr>
          <p:cNvCxnSpPr>
            <a:cxnSpLocks/>
          </p:cNvCxnSpPr>
          <p:nvPr/>
        </p:nvCxnSpPr>
        <p:spPr>
          <a:xfrm>
            <a:off x="1095375" y="1009650"/>
            <a:ext cx="89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xmlns="" id="{1E5A6A57-93FA-4BD7-B62C-EA97FC518980}"/>
              </a:ext>
            </a:extLst>
          </p:cNvPr>
          <p:cNvCxnSpPr>
            <a:cxnSpLocks/>
          </p:cNvCxnSpPr>
          <p:nvPr/>
        </p:nvCxnSpPr>
        <p:spPr>
          <a:xfrm>
            <a:off x="2009775" y="1009650"/>
            <a:ext cx="89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xmlns="" id="{64C6080C-A039-41E2-A70A-ED969744B1E6}"/>
              </a:ext>
            </a:extLst>
          </p:cNvPr>
          <p:cNvCxnSpPr>
            <a:cxnSpLocks/>
          </p:cNvCxnSpPr>
          <p:nvPr/>
        </p:nvCxnSpPr>
        <p:spPr>
          <a:xfrm>
            <a:off x="2971800" y="1009650"/>
            <a:ext cx="89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xmlns="" id="{253022D6-DE34-4405-BDFA-DBE09DC0B56E}"/>
              </a:ext>
            </a:extLst>
          </p:cNvPr>
          <p:cNvCxnSpPr>
            <a:cxnSpLocks/>
          </p:cNvCxnSpPr>
          <p:nvPr/>
        </p:nvCxnSpPr>
        <p:spPr>
          <a:xfrm>
            <a:off x="3962400" y="1009650"/>
            <a:ext cx="89535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254197F8-6FCF-4256-877A-94AB9DDC2590}"/>
              </a:ext>
            </a:extLst>
          </p:cNvPr>
          <p:cNvSpPr txBox="1"/>
          <p:nvPr/>
        </p:nvSpPr>
        <p:spPr>
          <a:xfrm>
            <a:off x="1409700" y="814059"/>
            <a:ext cx="50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xmlns="" id="{C9925934-7652-4A5E-8904-2F441DB2681B}"/>
              </a:ext>
            </a:extLst>
          </p:cNvPr>
          <p:cNvSpPr txBox="1"/>
          <p:nvPr/>
        </p:nvSpPr>
        <p:spPr>
          <a:xfrm>
            <a:off x="2295525" y="814059"/>
            <a:ext cx="70300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2.5 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xmlns="" id="{BD6C2C48-BF8C-4B31-A24B-A2A0AA2BA7F0}"/>
              </a:ext>
            </a:extLst>
          </p:cNvPr>
          <p:cNvSpPr txBox="1"/>
          <p:nvPr/>
        </p:nvSpPr>
        <p:spPr>
          <a:xfrm>
            <a:off x="3257550" y="814059"/>
            <a:ext cx="50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xmlns="" id="{E2E49BA0-F0DD-43ED-94A7-CEE54A95B00C}"/>
              </a:ext>
            </a:extLst>
          </p:cNvPr>
          <p:cNvSpPr txBox="1"/>
          <p:nvPr/>
        </p:nvSpPr>
        <p:spPr>
          <a:xfrm>
            <a:off x="4201871" y="814059"/>
            <a:ext cx="5048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xmlns="" id="{0B0D8EAB-CB71-4DC8-92C1-9CA37E44C992}"/>
              </a:ext>
            </a:extLst>
          </p:cNvPr>
          <p:cNvSpPr txBox="1"/>
          <p:nvPr/>
        </p:nvSpPr>
        <p:spPr>
          <a:xfrm>
            <a:off x="3933825" y="574342"/>
            <a:ext cx="1002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HPX</a:t>
            </a:r>
            <a:r>
              <a:rPr lang="en-GB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% v/v)</a:t>
            </a:r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xmlns="" id="{E2D367A8-9648-4F4B-8553-96C0691AFB02}"/>
              </a:ext>
            </a:extLst>
          </p:cNvPr>
          <p:cNvCxnSpPr>
            <a:cxnSpLocks/>
          </p:cNvCxnSpPr>
          <p:nvPr/>
        </p:nvCxnSpPr>
        <p:spPr>
          <a:xfrm>
            <a:off x="2009775" y="809625"/>
            <a:ext cx="18573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xmlns="" id="{ECB282B2-92ED-4DA7-9886-EDE04A24BE2F}"/>
              </a:ext>
            </a:extLst>
          </p:cNvPr>
          <p:cNvCxnSpPr>
            <a:cxnSpLocks/>
          </p:cNvCxnSpPr>
          <p:nvPr/>
        </p:nvCxnSpPr>
        <p:spPr>
          <a:xfrm>
            <a:off x="3929062" y="809625"/>
            <a:ext cx="928688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>
            <a:extLst>
              <a:ext uri="{FF2B5EF4-FFF2-40B4-BE49-F238E27FC236}">
                <a16:creationId xmlns:a16="http://schemas.microsoft.com/office/drawing/2014/main" xmlns="" id="{E4D685C7-ED60-4015-A70B-62211B1FC6EA}"/>
              </a:ext>
            </a:extLst>
          </p:cNvPr>
          <p:cNvSpPr txBox="1"/>
          <p:nvPr/>
        </p:nvSpPr>
        <p:spPr>
          <a:xfrm>
            <a:off x="2379596" y="588482"/>
            <a:ext cx="1002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HPX</a:t>
            </a:r>
            <a:r>
              <a:rPr lang="en-GB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GB" sz="1000" b="1" dirty="0">
                <a:latin typeface="Arial" panose="020B0604020202020204" pitchFamily="34" charset="0"/>
                <a:cs typeface="Arial" panose="020B0604020202020204" pitchFamily="34" charset="0"/>
              </a:rPr>
              <a:t>(% v/v)</a:t>
            </a:r>
          </a:p>
        </p:txBody>
      </p:sp>
      <p:grpSp>
        <p:nvGrpSpPr>
          <p:cNvPr id="40" name="Group 39">
            <a:extLst>
              <a:ext uri="{FF2B5EF4-FFF2-40B4-BE49-F238E27FC236}">
                <a16:creationId xmlns:a16="http://schemas.microsoft.com/office/drawing/2014/main" xmlns="" id="{06D18F30-79A7-4CD8-9A11-3A6C65D7E0B7}"/>
              </a:ext>
            </a:extLst>
          </p:cNvPr>
          <p:cNvGrpSpPr/>
          <p:nvPr/>
        </p:nvGrpSpPr>
        <p:grpSpPr>
          <a:xfrm>
            <a:off x="6372225" y="171788"/>
            <a:ext cx="3178850" cy="1585732"/>
            <a:chOff x="6372225" y="171788"/>
            <a:chExt cx="3178850" cy="1585732"/>
          </a:xfrm>
        </p:grpSpPr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xmlns="" id="{BB6A6966-5C31-494D-B2CA-54C7566404E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247" t="51769" r="9118" b="11438"/>
            <a:stretch/>
          </p:blipFill>
          <p:spPr>
            <a:xfrm>
              <a:off x="6372225" y="1079841"/>
              <a:ext cx="2552700" cy="2769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xmlns="" id="{147A145B-A74E-4303-8794-C35EA2708A1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841" t="58084" r="9777" b="15029"/>
            <a:stretch/>
          </p:blipFill>
          <p:spPr>
            <a:xfrm>
              <a:off x="6372225" y="1480521"/>
              <a:ext cx="2552700" cy="276999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xmlns="" id="{8E7750E4-A257-4990-A823-ECC32113CF42}"/>
                </a:ext>
              </a:extLst>
            </p:cNvPr>
            <p:cNvSpPr txBox="1"/>
            <p:nvPr/>
          </p:nvSpPr>
          <p:spPr>
            <a:xfrm>
              <a:off x="8907716" y="1079841"/>
              <a:ext cx="5116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D59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xmlns="" id="{032C8F69-C73A-4A38-8932-3D9B696385A5}"/>
                </a:ext>
              </a:extLst>
            </p:cNvPr>
            <p:cNvSpPr txBox="1"/>
            <p:nvPr/>
          </p:nvSpPr>
          <p:spPr>
            <a:xfrm>
              <a:off x="8903141" y="1473518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0972F438-1A96-4F7A-B700-A6A7DC77F610}"/>
                </a:ext>
              </a:extLst>
            </p:cNvPr>
            <p:cNvSpPr txBox="1"/>
            <p:nvPr/>
          </p:nvSpPr>
          <p:spPr>
            <a:xfrm>
              <a:off x="6413588" y="845347"/>
              <a:ext cx="819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NS    2.5    10     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FADCC035-9DE0-49CF-809F-17CC0E553310}"/>
                </a:ext>
              </a:extLst>
            </p:cNvPr>
            <p:cNvSpPr txBox="1"/>
            <p:nvPr/>
          </p:nvSpPr>
          <p:spPr>
            <a:xfrm>
              <a:off x="7587231" y="844778"/>
              <a:ext cx="81960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NS    2.5    10     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CA4B378D-4010-46B2-A741-C50DEB1A3BDB}"/>
                </a:ext>
              </a:extLst>
            </p:cNvPr>
            <p:cNvSpPr txBox="1"/>
            <p:nvPr/>
          </p:nvSpPr>
          <p:spPr>
            <a:xfrm>
              <a:off x="6585453" y="699882"/>
              <a:ext cx="7724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  <a:r>
                <a: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% v/v)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311BB8A5-0288-4F51-9B6E-3A3CA36A7871}"/>
                </a:ext>
              </a:extLst>
            </p:cNvPr>
            <p:cNvSpPr txBox="1"/>
            <p:nvPr/>
          </p:nvSpPr>
          <p:spPr>
            <a:xfrm>
              <a:off x="7768923" y="690569"/>
              <a:ext cx="77245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  <a:r>
                <a: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% v/v)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xmlns="" id="{89F8C28A-AF33-47D6-997B-53B89DCE5C81}"/>
                </a:ext>
              </a:extLst>
            </p:cNvPr>
            <p:cNvSpPr txBox="1"/>
            <p:nvPr/>
          </p:nvSpPr>
          <p:spPr>
            <a:xfrm rot="18011686">
              <a:off x="7099841" y="565473"/>
              <a:ext cx="1002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0 % HPX</a:t>
              </a:r>
              <a:r>
                <a: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 v/v)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xmlns="" id="{A081F6BE-5866-4B0F-9207-9D61B823DC2C}"/>
                </a:ext>
              </a:extLst>
            </p:cNvPr>
            <p:cNvSpPr txBox="1"/>
            <p:nvPr/>
          </p:nvSpPr>
          <p:spPr>
            <a:xfrm rot="18150694">
              <a:off x="8292764" y="574250"/>
              <a:ext cx="100281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10 % HPX</a:t>
              </a:r>
              <a:r>
                <a:rPr lang="en-GB" sz="8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( v/v)</a:t>
              </a:r>
            </a:p>
          </p:txBody>
        </p: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xmlns="" id="{4DD44EDD-F498-4943-9047-D1D901126CE4}"/>
                </a:ext>
              </a:extLst>
            </p:cNvPr>
            <p:cNvCxnSpPr>
              <a:cxnSpLocks/>
            </p:cNvCxnSpPr>
            <p:nvPr/>
          </p:nvCxnSpPr>
          <p:spPr>
            <a:xfrm>
              <a:off x="6372225" y="1022180"/>
              <a:ext cx="8953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>
              <a:extLst>
                <a:ext uri="{FF2B5EF4-FFF2-40B4-BE49-F238E27FC236}">
                  <a16:creationId xmlns:a16="http://schemas.microsoft.com/office/drawing/2014/main" xmlns="" id="{A765F050-60CB-47C4-B55B-075B627B7533}"/>
                </a:ext>
              </a:extLst>
            </p:cNvPr>
            <p:cNvCxnSpPr>
              <a:cxnSpLocks/>
            </p:cNvCxnSpPr>
            <p:nvPr/>
          </p:nvCxnSpPr>
          <p:spPr>
            <a:xfrm>
              <a:off x="7581900" y="1031705"/>
              <a:ext cx="89535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93D78C8F-2861-4C8D-994C-499EE5B09009}"/>
              </a:ext>
            </a:extLst>
          </p:cNvPr>
          <p:cNvSpPr txBox="1"/>
          <p:nvPr/>
        </p:nvSpPr>
        <p:spPr>
          <a:xfrm>
            <a:off x="667979" y="2486285"/>
            <a:ext cx="10485796" cy="574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</a:t>
            </a:r>
            <a:r>
              <a:rPr lang="en-US" sz="11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1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iginal western blot.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lomeruli were incubated with media containing no serum (NS), various amounts of HPX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¯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rum (2.5%, 10% v/v) or with HPX</a:t>
            </a:r>
            <a:r>
              <a:rPr lang="en-US" sz="11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 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erum (10%) for 18 hours. Total protein lysates were analyzed by western blotting for: a) DAF, b) </a:t>
            </a:r>
            <a:r>
              <a:rPr lang="en-US" sz="11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ry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and c) CD59 glomerular expression. GAPDH was used as loading control.</a:t>
            </a:r>
            <a:endParaRPr lang="en-GB" sz="11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97297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xmlns="" id="{CA07D64D-294C-4575-85CB-B0BD5CE33AC5}"/>
              </a:ext>
            </a:extLst>
          </p:cNvPr>
          <p:cNvGrpSpPr/>
          <p:nvPr/>
        </p:nvGrpSpPr>
        <p:grpSpPr>
          <a:xfrm>
            <a:off x="1052890" y="778931"/>
            <a:ext cx="3321022" cy="1813494"/>
            <a:chOff x="1052890" y="778931"/>
            <a:chExt cx="3321022" cy="1813494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698F37ED-410E-4919-B9E7-AA9A3ED059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61" t="21932" r="5321" b="15448"/>
            <a:stretch/>
          </p:blipFill>
          <p:spPr>
            <a:xfrm>
              <a:off x="1053172" y="1452491"/>
              <a:ext cx="2237144" cy="345977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1524D4E7-F898-4533-AA36-EFAB50627E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1053172" y="1896965"/>
              <a:ext cx="2237426" cy="34750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5AFFA11C-716C-4D93-B1D3-4D39EE8A771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004" t="24216" r="31680" b="52403"/>
            <a:stretch/>
          </p:blipFill>
          <p:spPr>
            <a:xfrm>
              <a:off x="1052890" y="2390589"/>
              <a:ext cx="2237426" cy="17229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xmlns="" id="{8A57BC84-B02B-4C83-9ECA-7C47910FD2AD}"/>
                </a:ext>
              </a:extLst>
            </p:cNvPr>
            <p:cNvSpPr txBox="1"/>
            <p:nvPr/>
          </p:nvSpPr>
          <p:spPr>
            <a:xfrm>
              <a:off x="3272612" y="1476047"/>
              <a:ext cx="44916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AF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xmlns="" id="{C33F8ACA-EAF6-4670-80CD-00AB67F18FAE}"/>
                </a:ext>
              </a:extLst>
            </p:cNvPr>
            <p:cNvSpPr txBox="1"/>
            <p:nvPr/>
          </p:nvSpPr>
          <p:spPr>
            <a:xfrm>
              <a:off x="3242691" y="2346204"/>
              <a:ext cx="64793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xmlns="" id="{E0FD5440-675D-4465-ABF6-4EFA9B980399}"/>
                </a:ext>
              </a:extLst>
            </p:cNvPr>
            <p:cNvSpPr txBox="1"/>
            <p:nvPr/>
          </p:nvSpPr>
          <p:spPr>
            <a:xfrm>
              <a:off x="3263087" y="1957033"/>
              <a:ext cx="44755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rry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58A56D70-0BEA-40F6-93EE-39BA74EADA3E}"/>
                </a:ext>
              </a:extLst>
            </p:cNvPr>
            <p:cNvSpPr txBox="1"/>
            <p:nvPr/>
          </p:nvSpPr>
          <p:spPr>
            <a:xfrm>
              <a:off x="3281463" y="1241942"/>
              <a:ext cx="92858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emin (</a:t>
              </a:r>
              <a:r>
                <a:rPr lang="el-GR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μΜ)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xmlns="" id="{DB82AA8D-5C19-4F42-8234-535B944D649F}"/>
                </a:ext>
              </a:extLst>
            </p:cNvPr>
            <p:cNvSpPr txBox="1"/>
            <p:nvPr/>
          </p:nvSpPr>
          <p:spPr>
            <a:xfrm>
              <a:off x="3290316" y="1035891"/>
              <a:ext cx="105349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  <a:r>
                <a:rPr lang="en-GB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10% v/v)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7B1E90B2-7E90-4AE1-B457-08358546DE10}"/>
                </a:ext>
              </a:extLst>
            </p:cNvPr>
            <p:cNvSpPr txBox="1"/>
            <p:nvPr/>
          </p:nvSpPr>
          <p:spPr>
            <a:xfrm>
              <a:off x="1153005" y="1241942"/>
              <a:ext cx="1018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200    400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6269446C-A434-4AAF-8D95-900CBADEBB85}"/>
                </a:ext>
              </a:extLst>
            </p:cNvPr>
            <p:cNvSpPr txBox="1"/>
            <p:nvPr/>
          </p:nvSpPr>
          <p:spPr>
            <a:xfrm>
              <a:off x="2122171" y="1241942"/>
              <a:ext cx="101859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0     200    40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xmlns="" id="{BD48D692-17BD-45F4-91A3-897EB7D3E49E}"/>
                </a:ext>
              </a:extLst>
            </p:cNvPr>
            <p:cNvSpPr txBox="1"/>
            <p:nvPr/>
          </p:nvSpPr>
          <p:spPr>
            <a:xfrm>
              <a:off x="3299579" y="778931"/>
              <a:ext cx="107433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  <a:r>
                <a:rPr lang="en-GB" sz="1000" b="1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(10% v/v)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xmlns="" id="{E66BFC33-6D0E-4E85-9BB7-3B0862F25137}"/>
                </a:ext>
              </a:extLst>
            </p:cNvPr>
            <p:cNvSpPr txBox="1"/>
            <p:nvPr/>
          </p:nvSpPr>
          <p:spPr>
            <a:xfrm>
              <a:off x="1150719" y="1013800"/>
              <a:ext cx="191590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-         -       +       +        +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xmlns="" id="{40322CEE-0D16-450C-B232-1CAE13CF3ABC}"/>
                </a:ext>
              </a:extLst>
            </p:cNvPr>
            <p:cNvSpPr txBox="1"/>
            <p:nvPr/>
          </p:nvSpPr>
          <p:spPr>
            <a:xfrm>
              <a:off x="1150718" y="784574"/>
              <a:ext cx="190949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+       +        +       -        -        -</a:t>
              </a:r>
            </a:p>
          </p:txBody>
        </p: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F6CDDED-E2E9-4701-A540-F3087389D29B}"/>
              </a:ext>
            </a:extLst>
          </p:cNvPr>
          <p:cNvSpPr txBox="1"/>
          <p:nvPr/>
        </p:nvSpPr>
        <p:spPr>
          <a:xfrm>
            <a:off x="361950" y="2887044"/>
            <a:ext cx="11315699" cy="443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69875" marR="269875"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igure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2 </a:t>
            </a:r>
            <a:r>
              <a:rPr lang="en-US" sz="12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original western blot. 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olated glomeruli were incubated with 10% HPX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¯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or 10% HPX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+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erum in the presence of exogenous hemin (200, 400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μM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) for 18 hours. Total protein lysates were analyzed by western blotting for DAF of </a:t>
            </a:r>
            <a:r>
              <a:rPr lang="en-US" sz="1200" dirty="0" err="1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rry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protein. β-actin was used as loading control.</a:t>
            </a:r>
            <a:endParaRPr lang="en-GB" sz="1200" dirty="0">
              <a:solidFill>
                <a:srgbClr val="000000"/>
              </a:solidFill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54934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9</TotalTime>
  <Words>215</Words>
  <Application>Microsoft Office PowerPoint</Application>
  <PresentationFormat>Widescreen</PresentationFormat>
  <Paragraphs>29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ΑΝΤΙΓΟΝΗ ΛΟΒΕΡΔΟΥ</dc:creator>
  <cp:lastModifiedBy>Microsoft account</cp:lastModifiedBy>
  <cp:revision>5</cp:revision>
  <dcterms:created xsi:type="dcterms:W3CDTF">2021-08-16T18:38:17Z</dcterms:created>
  <dcterms:modified xsi:type="dcterms:W3CDTF">2021-09-07T06:34:31Z</dcterms:modified>
</cp:coreProperties>
</file>